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40A30-DF37-49C6-8A0E-302938FA7B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A65C4-B731-4CDE-9F0B-F898D75536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FE672-3B4A-448E-8CB2-8EFA89D789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6CA81-41B5-4BB0-B0F3-093FCCDE60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A4E84-E454-4A01-9DC6-CD358DD5FB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D28F7-D552-4BB9-A5DA-3BC88A09A4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CA55F-3232-4239-A14E-E2F8DBC875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84001-BC90-4326-9B0C-D65061AF78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8D554-F13C-4668-AD99-4954FA8820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A528D-9426-4252-AC26-92A179F828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899E8-4CA1-483F-AAC6-243183DAE2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A4B51-84EE-4AC3-9C5A-4B2A94E636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80E665-B0A0-43DD-A8DD-13B8B04E32CD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460440" y="4643280"/>
            <a:ext cx="340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11"/>
          <p:cNvSpPr/>
          <p:nvPr/>
        </p:nvSpPr>
        <p:spPr>
          <a:xfrm>
            <a:off x="460440" y="436680"/>
            <a:ext cx="340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3" name="그림 2" descr=""/>
          <p:cNvPicPr/>
          <p:nvPr/>
        </p:nvPicPr>
        <p:blipFill>
          <a:blip r:embed="rId1"/>
          <a:srcRect l="1703" t="8074" r="1703" b="2990"/>
          <a:stretch/>
        </p:blipFill>
        <p:spPr>
          <a:xfrm>
            <a:off x="836640" y="755640"/>
            <a:ext cx="5113440" cy="3889440"/>
          </a:xfrm>
          <a:prstGeom prst="rect">
            <a:avLst/>
          </a:prstGeom>
          <a:ln w="0">
            <a:noFill/>
          </a:ln>
        </p:spPr>
      </p:pic>
      <p:pic>
        <p:nvPicPr>
          <p:cNvPr id="44" name="그림 3" descr=""/>
          <p:cNvPicPr/>
          <p:nvPr/>
        </p:nvPicPr>
        <p:blipFill>
          <a:blip r:embed="rId2"/>
          <a:srcRect l="2750" t="14635" r="3799" b="8085"/>
          <a:stretch/>
        </p:blipFill>
        <p:spPr>
          <a:xfrm>
            <a:off x="1203480" y="5022720"/>
            <a:ext cx="4752720" cy="3151440"/>
          </a:xfrm>
          <a:prstGeom prst="rect">
            <a:avLst/>
          </a:prstGeom>
          <a:ln w="0">
            <a:noFill/>
          </a:ln>
        </p:spPr>
      </p:pic>
      <p:sp>
        <p:nvSpPr>
          <p:cNvPr id="45" name="TextBox 11"/>
          <p:cNvSpPr/>
          <p:nvPr/>
        </p:nvSpPr>
        <p:spPr>
          <a:xfrm>
            <a:off x="260280" y="8172360"/>
            <a:ext cx="64818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 |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hosphotransferase system and one carbon pool created by formate pathways in MRSA treated with NaP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hosphotransferase system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one carbon pool created by folate pathways in MRSA treated with NaP are represented. Green and red highlights indicate up- and down-regulated DEGs in the assigned pathway, respectively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1528920" y="-36360"/>
            <a:ext cx="381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2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07:45:37Z</dcterms:created>
  <dc:creator>조민경</dc:creator>
  <dc:description/>
  <dc:language>en-US</dc:language>
  <cp:lastModifiedBy>임진택</cp:lastModifiedBy>
  <cp:lastPrinted>2022-01-06T07:05:04Z</cp:lastPrinted>
  <dcterms:modified xsi:type="dcterms:W3CDTF">2022-10-04T08:53:15Z</dcterms:modified>
  <cp:revision>511</cp:revision>
  <dc:subject/>
  <dc:title>슬라이드 1</dc:title>
</cp:coreProperties>
</file>